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sldIdLst>
    <p:sldId id="279" r:id="rId2"/>
    <p:sldId id="286" r:id="rId3"/>
    <p:sldId id="277" r:id="rId4"/>
    <p:sldId id="267" r:id="rId5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BB6C5BF-FF8B-47DB-A14B-4C5926352A07}" v="15" dt="2022-11-12T02:38:27.869"/>
  </p1510:revLst>
</p1510:revInfo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799B23B-EC83-4686-B30A-512413B5E67A}" styleName="Light Style 3 - Accent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3"/>
              </a:solidFill>
            </a:ln>
          </a:left>
          <a:right>
            <a:ln w="12700" cmpd="sng">
              <a:solidFill>
                <a:schemeClr val="accent3"/>
              </a:solidFill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 w="12700" cmpd="sng">
              <a:solidFill>
                <a:schemeClr val="accent3"/>
              </a:solidFill>
            </a:ln>
          </a:insideH>
          <a:insideV>
            <a:ln w="12700" cmpd="sng">
              <a:solidFill>
                <a:schemeClr val="accent3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5258"/>
    <p:restoredTop sz="94635"/>
  </p:normalViewPr>
  <p:slideViewPr>
    <p:cSldViewPr snapToGrid="0" snapToObjects="1">
      <p:cViewPr>
        <p:scale>
          <a:sx n="130" d="100"/>
          <a:sy n="130" d="100"/>
        </p:scale>
        <p:origin x="-162" y="-206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11" Type="http://schemas.microsoft.com/office/2015/10/relationships/revisionInfo" Target="revisionInfo.xml"/><Relationship Id="rId5" Type="http://schemas.openxmlformats.org/officeDocument/2006/relationships/slide" Target="slides/slide4.xml"/><Relationship Id="rId10" Type="http://schemas.microsoft.com/office/2016/11/relationships/changesInfo" Target="changesInfos/changesInfo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su, Robert" userId="a49bd464-34e2-45dd-a34f-7e5b363136eb" providerId="ADAL" clId="{6BB6C5BF-FF8B-47DB-A14B-4C5926352A07}"/>
    <pc:docChg chg="undo custSel delSld modSld">
      <pc:chgData name="Hsu, Robert" userId="a49bd464-34e2-45dd-a34f-7e5b363136eb" providerId="ADAL" clId="{6BB6C5BF-FF8B-47DB-A14B-4C5926352A07}" dt="2022-11-12T02:38:43.706" v="697" actId="20577"/>
      <pc:docMkLst>
        <pc:docMk/>
      </pc:docMkLst>
      <pc:sldChg chg="modSp del mod">
        <pc:chgData name="Hsu, Robert" userId="a49bd464-34e2-45dd-a34f-7e5b363136eb" providerId="ADAL" clId="{6BB6C5BF-FF8B-47DB-A14B-4C5926352A07}" dt="2022-11-02T22:41:55.109" v="13" actId="2696"/>
        <pc:sldMkLst>
          <pc:docMk/>
          <pc:sldMk cId="2031508663" sldId="256"/>
        </pc:sldMkLst>
        <pc:spChg chg="mod">
          <ac:chgData name="Hsu, Robert" userId="a49bd464-34e2-45dd-a34f-7e5b363136eb" providerId="ADAL" clId="{6BB6C5BF-FF8B-47DB-A14B-4C5926352A07}" dt="2022-11-02T22:41:52.124" v="12" actId="20577"/>
          <ac:spMkLst>
            <pc:docMk/>
            <pc:sldMk cId="2031508663" sldId="256"/>
            <ac:spMk id="2" creationId="{4BBDF6CE-F1DF-E642-AFC2-A21E92CE9E58}"/>
          </ac:spMkLst>
        </pc:spChg>
      </pc:sldChg>
      <pc:sldChg chg="del">
        <pc:chgData name="Hsu, Robert" userId="a49bd464-34e2-45dd-a34f-7e5b363136eb" providerId="ADAL" clId="{6BB6C5BF-FF8B-47DB-A14B-4C5926352A07}" dt="2022-11-02T22:41:56.732" v="14" actId="2696"/>
        <pc:sldMkLst>
          <pc:docMk/>
          <pc:sldMk cId="4208419247" sldId="257"/>
        </pc:sldMkLst>
      </pc:sldChg>
      <pc:sldChg chg="del">
        <pc:chgData name="Hsu, Robert" userId="a49bd464-34e2-45dd-a34f-7e5b363136eb" providerId="ADAL" clId="{6BB6C5BF-FF8B-47DB-A14B-4C5926352A07}" dt="2022-11-02T22:42:03.837" v="18" actId="2696"/>
        <pc:sldMkLst>
          <pc:docMk/>
          <pc:sldMk cId="3311008906" sldId="261"/>
        </pc:sldMkLst>
      </pc:sldChg>
      <pc:sldChg chg="modSp mod">
        <pc:chgData name="Hsu, Robert" userId="a49bd464-34e2-45dd-a34f-7e5b363136eb" providerId="ADAL" clId="{6BB6C5BF-FF8B-47DB-A14B-4C5926352A07}" dt="2022-11-12T02:38:43.706" v="697" actId="20577"/>
        <pc:sldMkLst>
          <pc:docMk/>
          <pc:sldMk cId="1293377712" sldId="267"/>
        </pc:sldMkLst>
        <pc:spChg chg="mod">
          <ac:chgData name="Hsu, Robert" userId="a49bd464-34e2-45dd-a34f-7e5b363136eb" providerId="ADAL" clId="{6BB6C5BF-FF8B-47DB-A14B-4C5926352A07}" dt="2022-11-12T02:38:43.706" v="697" actId="20577"/>
          <ac:spMkLst>
            <pc:docMk/>
            <pc:sldMk cId="1293377712" sldId="267"/>
            <ac:spMk id="7" creationId="{93D813AD-107F-AE4A-B472-868A7360B4EF}"/>
          </ac:spMkLst>
        </pc:spChg>
        <pc:graphicFrameChg chg="modGraphic">
          <ac:chgData name="Hsu, Robert" userId="a49bd464-34e2-45dd-a34f-7e5b363136eb" providerId="ADAL" clId="{6BB6C5BF-FF8B-47DB-A14B-4C5926352A07}" dt="2022-11-02T23:01:42.789" v="442" actId="20577"/>
          <ac:graphicFrameMkLst>
            <pc:docMk/>
            <pc:sldMk cId="1293377712" sldId="267"/>
            <ac:graphicFrameMk id="4" creationId="{99D40D41-F8D5-244F-96CA-26E041772AF8}"/>
          </ac:graphicFrameMkLst>
        </pc:graphicFrameChg>
      </pc:sldChg>
      <pc:sldChg chg="del">
        <pc:chgData name="Hsu, Robert" userId="a49bd464-34e2-45dd-a34f-7e5b363136eb" providerId="ADAL" clId="{6BB6C5BF-FF8B-47DB-A14B-4C5926352A07}" dt="2022-11-02T22:42:05.746" v="19" actId="2696"/>
        <pc:sldMkLst>
          <pc:docMk/>
          <pc:sldMk cId="3403811506" sldId="270"/>
        </pc:sldMkLst>
      </pc:sldChg>
      <pc:sldChg chg="del">
        <pc:chgData name="Hsu, Robert" userId="a49bd464-34e2-45dd-a34f-7e5b363136eb" providerId="ADAL" clId="{6BB6C5BF-FF8B-47DB-A14B-4C5926352A07}" dt="2022-11-02T22:42:10.617" v="21" actId="2696"/>
        <pc:sldMkLst>
          <pc:docMk/>
          <pc:sldMk cId="733038330" sldId="276"/>
        </pc:sldMkLst>
      </pc:sldChg>
      <pc:sldChg chg="modSp mod">
        <pc:chgData name="Hsu, Robert" userId="a49bd464-34e2-45dd-a34f-7e5b363136eb" providerId="ADAL" clId="{6BB6C5BF-FF8B-47DB-A14B-4C5926352A07}" dt="2022-11-12T02:38:38.760" v="695" actId="20577"/>
        <pc:sldMkLst>
          <pc:docMk/>
          <pc:sldMk cId="2719242194" sldId="277"/>
        </pc:sldMkLst>
        <pc:spChg chg="mod">
          <ac:chgData name="Hsu, Robert" userId="a49bd464-34e2-45dd-a34f-7e5b363136eb" providerId="ADAL" clId="{6BB6C5BF-FF8B-47DB-A14B-4C5926352A07}" dt="2022-11-12T02:38:38.760" v="695" actId="20577"/>
          <ac:spMkLst>
            <pc:docMk/>
            <pc:sldMk cId="2719242194" sldId="277"/>
            <ac:spMk id="7" creationId="{54E3888B-9A84-A042-9920-61F2043E5AAA}"/>
          </ac:spMkLst>
        </pc:spChg>
      </pc:sldChg>
      <pc:sldChg chg="del">
        <pc:chgData name="Hsu, Robert" userId="a49bd464-34e2-45dd-a34f-7e5b363136eb" providerId="ADAL" clId="{6BB6C5BF-FF8B-47DB-A14B-4C5926352A07}" dt="2022-11-02T22:41:58.971" v="15" actId="2696"/>
        <pc:sldMkLst>
          <pc:docMk/>
          <pc:sldMk cId="1921386427" sldId="278"/>
        </pc:sldMkLst>
      </pc:sldChg>
      <pc:sldChg chg="delSp modSp mod">
        <pc:chgData name="Hsu, Robert" userId="a49bd464-34e2-45dd-a34f-7e5b363136eb" providerId="ADAL" clId="{6BB6C5BF-FF8B-47DB-A14B-4C5926352A07}" dt="2022-11-12T02:34:28.827" v="673" actId="1076"/>
        <pc:sldMkLst>
          <pc:docMk/>
          <pc:sldMk cId="1360789988" sldId="279"/>
        </pc:sldMkLst>
        <pc:spChg chg="del">
          <ac:chgData name="Hsu, Robert" userId="a49bd464-34e2-45dd-a34f-7e5b363136eb" providerId="ADAL" clId="{6BB6C5BF-FF8B-47DB-A14B-4C5926352A07}" dt="2022-11-02T22:42:14.750" v="23" actId="478"/>
          <ac:spMkLst>
            <pc:docMk/>
            <pc:sldMk cId="1360789988" sldId="279"/>
            <ac:spMk id="6" creationId="{C9E7AB0E-BAD0-1044-BA9C-3187AC4EEB73}"/>
          </ac:spMkLst>
        </pc:spChg>
        <pc:spChg chg="mod">
          <ac:chgData name="Hsu, Robert" userId="a49bd464-34e2-45dd-a34f-7e5b363136eb" providerId="ADAL" clId="{6BB6C5BF-FF8B-47DB-A14B-4C5926352A07}" dt="2022-11-12T02:34:28.827" v="673" actId="1076"/>
          <ac:spMkLst>
            <pc:docMk/>
            <pc:sldMk cId="1360789988" sldId="279"/>
            <ac:spMk id="8" creationId="{F3077FF9-5133-BD40-838A-B93A5FD945D7}"/>
          </ac:spMkLst>
        </pc:spChg>
        <pc:graphicFrameChg chg="mod modGraphic">
          <ac:chgData name="Hsu, Robert" userId="a49bd464-34e2-45dd-a34f-7e5b363136eb" providerId="ADAL" clId="{6BB6C5BF-FF8B-47DB-A14B-4C5926352A07}" dt="2022-11-12T02:34:07.194" v="628" actId="20577"/>
          <ac:graphicFrameMkLst>
            <pc:docMk/>
            <pc:sldMk cId="1360789988" sldId="279"/>
            <ac:graphicFrameMk id="7" creationId="{6F181412-1BB4-1344-A0D5-6C49E8C8A652}"/>
          </ac:graphicFrameMkLst>
        </pc:graphicFrameChg>
        <pc:graphicFrameChg chg="del">
          <ac:chgData name="Hsu, Robert" userId="a49bd464-34e2-45dd-a34f-7e5b363136eb" providerId="ADAL" clId="{6BB6C5BF-FF8B-47DB-A14B-4C5926352A07}" dt="2022-11-02T22:42:13.103" v="22" actId="478"/>
          <ac:graphicFrameMkLst>
            <pc:docMk/>
            <pc:sldMk cId="1360789988" sldId="279"/>
            <ac:graphicFrameMk id="10" creationId="{61C3BFA7-E108-40C6-AD32-B194319425B8}"/>
          </ac:graphicFrameMkLst>
        </pc:graphicFrameChg>
      </pc:sldChg>
      <pc:sldChg chg="delSp modSp del mod">
        <pc:chgData name="Hsu, Robert" userId="a49bd464-34e2-45dd-a34f-7e5b363136eb" providerId="ADAL" clId="{6BB6C5BF-FF8B-47DB-A14B-4C5926352A07}" dt="2022-11-12T02:34:33.256" v="674" actId="2696"/>
        <pc:sldMkLst>
          <pc:docMk/>
          <pc:sldMk cId="4053088459" sldId="280"/>
        </pc:sldMkLst>
        <pc:spChg chg="del">
          <ac:chgData name="Hsu, Robert" userId="a49bd464-34e2-45dd-a34f-7e5b363136eb" providerId="ADAL" clId="{6BB6C5BF-FF8B-47DB-A14B-4C5926352A07}" dt="2022-11-02T22:45:24.925" v="47" actId="478"/>
          <ac:spMkLst>
            <pc:docMk/>
            <pc:sldMk cId="4053088459" sldId="280"/>
            <ac:spMk id="5" creationId="{310D6672-6CB0-FD44-BCCA-B01E89765B1E}"/>
          </ac:spMkLst>
        </pc:spChg>
        <pc:spChg chg="del mod">
          <ac:chgData name="Hsu, Robert" userId="a49bd464-34e2-45dd-a34f-7e5b363136eb" providerId="ADAL" clId="{6BB6C5BF-FF8B-47DB-A14B-4C5926352A07}" dt="2022-11-12T02:24:55.892" v="468" actId="478"/>
          <ac:spMkLst>
            <pc:docMk/>
            <pc:sldMk cId="4053088459" sldId="280"/>
            <ac:spMk id="7" creationId="{F3A759D6-DE98-B740-930F-2E88033EFA3C}"/>
          </ac:spMkLst>
        </pc:spChg>
        <pc:graphicFrameChg chg="mod modGraphic">
          <ac:chgData name="Hsu, Robert" userId="a49bd464-34e2-45dd-a34f-7e5b363136eb" providerId="ADAL" clId="{6BB6C5BF-FF8B-47DB-A14B-4C5926352A07}" dt="2022-11-12T02:24:51.862" v="466" actId="1076"/>
          <ac:graphicFrameMkLst>
            <pc:docMk/>
            <pc:sldMk cId="4053088459" sldId="280"/>
            <ac:graphicFrameMk id="6" creationId="{39C0602C-12FB-0749-BDBF-20D0B839FDF7}"/>
          </ac:graphicFrameMkLst>
        </pc:graphicFrameChg>
        <pc:graphicFrameChg chg="del">
          <ac:chgData name="Hsu, Robert" userId="a49bd464-34e2-45dd-a34f-7e5b363136eb" providerId="ADAL" clId="{6BB6C5BF-FF8B-47DB-A14B-4C5926352A07}" dt="2022-11-02T22:45:26.274" v="48" actId="478"/>
          <ac:graphicFrameMkLst>
            <pc:docMk/>
            <pc:sldMk cId="4053088459" sldId="280"/>
            <ac:graphicFrameMk id="9" creationId="{C33FEA8C-BEBE-42BD-B9EF-436C1F66C8AA}"/>
          </ac:graphicFrameMkLst>
        </pc:graphicFrameChg>
      </pc:sldChg>
      <pc:sldChg chg="del">
        <pc:chgData name="Hsu, Robert" userId="a49bd464-34e2-45dd-a34f-7e5b363136eb" providerId="ADAL" clId="{6BB6C5BF-FF8B-47DB-A14B-4C5926352A07}" dt="2022-11-02T22:42:00.636" v="16" actId="2696"/>
        <pc:sldMkLst>
          <pc:docMk/>
          <pc:sldMk cId="1405312049" sldId="281"/>
        </pc:sldMkLst>
      </pc:sldChg>
      <pc:sldChg chg="addSp delSp modSp del mod">
        <pc:chgData name="Hsu, Robert" userId="a49bd464-34e2-45dd-a34f-7e5b363136eb" providerId="ADAL" clId="{6BB6C5BF-FF8B-47DB-A14B-4C5926352A07}" dt="2022-11-12T02:34:35.988" v="675" actId="2696"/>
        <pc:sldMkLst>
          <pc:docMk/>
          <pc:sldMk cId="1106272665" sldId="282"/>
        </pc:sldMkLst>
        <pc:spChg chg="del">
          <ac:chgData name="Hsu, Robert" userId="a49bd464-34e2-45dd-a34f-7e5b363136eb" providerId="ADAL" clId="{6BB6C5BF-FF8B-47DB-A14B-4C5926352A07}" dt="2022-11-02T22:47:13.358" v="61" actId="478"/>
          <ac:spMkLst>
            <pc:docMk/>
            <pc:sldMk cId="1106272665" sldId="282"/>
            <ac:spMk id="5" creationId="{2DE25069-0123-2B45-8762-5A57DB3CC721}"/>
          </ac:spMkLst>
        </pc:spChg>
        <pc:spChg chg="mod">
          <ac:chgData name="Hsu, Robert" userId="a49bd464-34e2-45dd-a34f-7e5b363136eb" providerId="ADAL" clId="{6BB6C5BF-FF8B-47DB-A14B-4C5926352A07}" dt="2022-11-02T22:50:17.534" v="182" actId="14100"/>
          <ac:spMkLst>
            <pc:docMk/>
            <pc:sldMk cId="1106272665" sldId="282"/>
            <ac:spMk id="8" creationId="{08D43FBD-3144-494C-993F-B8236C5DB3F2}"/>
          </ac:spMkLst>
        </pc:spChg>
        <pc:spChg chg="add mod">
          <ac:chgData name="Hsu, Robert" userId="a49bd464-34e2-45dd-a34f-7e5b363136eb" providerId="ADAL" clId="{6BB6C5BF-FF8B-47DB-A14B-4C5926352A07}" dt="2022-11-02T22:49:16.186" v="70"/>
          <ac:spMkLst>
            <pc:docMk/>
            <pc:sldMk cId="1106272665" sldId="282"/>
            <ac:spMk id="10" creationId="{63DE1BDB-E2B0-4F1C-B110-07F840EFF380}"/>
          </ac:spMkLst>
        </pc:spChg>
        <pc:spChg chg="add mod">
          <ac:chgData name="Hsu, Robert" userId="a49bd464-34e2-45dd-a34f-7e5b363136eb" providerId="ADAL" clId="{6BB6C5BF-FF8B-47DB-A14B-4C5926352A07}" dt="2022-11-02T22:49:31.583" v="76" actId="20577"/>
          <ac:spMkLst>
            <pc:docMk/>
            <pc:sldMk cId="1106272665" sldId="282"/>
            <ac:spMk id="11" creationId="{FF2C958B-D986-4B36-97DB-195B18AA4E43}"/>
          </ac:spMkLst>
        </pc:spChg>
        <pc:graphicFrameChg chg="del">
          <ac:chgData name="Hsu, Robert" userId="a49bd464-34e2-45dd-a34f-7e5b363136eb" providerId="ADAL" clId="{6BB6C5BF-FF8B-47DB-A14B-4C5926352A07}" dt="2022-11-02T22:47:11.523" v="60" actId="478"/>
          <ac:graphicFrameMkLst>
            <pc:docMk/>
            <pc:sldMk cId="1106272665" sldId="282"/>
            <ac:graphicFrameMk id="6" creationId="{379F8A29-1441-44AC-9296-AFF9B57EDC58}"/>
          </ac:graphicFrameMkLst>
        </pc:graphicFrameChg>
        <pc:graphicFrameChg chg="mod modGraphic">
          <ac:chgData name="Hsu, Robert" userId="a49bd464-34e2-45dd-a34f-7e5b363136eb" providerId="ADAL" clId="{6BB6C5BF-FF8B-47DB-A14B-4C5926352A07}" dt="2022-11-12T02:28:26.337" v="484" actId="20577"/>
          <ac:graphicFrameMkLst>
            <pc:docMk/>
            <pc:sldMk cId="1106272665" sldId="282"/>
            <ac:graphicFrameMk id="7" creationId="{097D1334-AF40-A14E-8FFC-E355798D9718}"/>
          </ac:graphicFrameMkLst>
        </pc:graphicFrameChg>
        <pc:graphicFrameChg chg="add mod modGraphic">
          <ac:chgData name="Hsu, Robert" userId="a49bd464-34e2-45dd-a34f-7e5b363136eb" providerId="ADAL" clId="{6BB6C5BF-FF8B-47DB-A14B-4C5926352A07}" dt="2022-11-12T02:29:37.826" v="501" actId="20577"/>
          <ac:graphicFrameMkLst>
            <pc:docMk/>
            <pc:sldMk cId="1106272665" sldId="282"/>
            <ac:graphicFrameMk id="9" creationId="{2F3D810C-6279-4791-8891-78545E22B8F2}"/>
          </ac:graphicFrameMkLst>
        </pc:graphicFrameChg>
      </pc:sldChg>
      <pc:sldChg chg="del">
        <pc:chgData name="Hsu, Robert" userId="a49bd464-34e2-45dd-a34f-7e5b363136eb" providerId="ADAL" clId="{6BB6C5BF-FF8B-47DB-A14B-4C5926352A07}" dt="2022-11-02T22:50:29.123" v="183" actId="2696"/>
        <pc:sldMkLst>
          <pc:docMk/>
          <pc:sldMk cId="2497361240" sldId="283"/>
        </pc:sldMkLst>
      </pc:sldChg>
      <pc:sldChg chg="addSp delSp modSp del mod">
        <pc:chgData name="Hsu, Robert" userId="a49bd464-34e2-45dd-a34f-7e5b363136eb" providerId="ADAL" clId="{6BB6C5BF-FF8B-47DB-A14B-4C5926352A07}" dt="2022-11-12T02:34:38.258" v="676" actId="2696"/>
        <pc:sldMkLst>
          <pc:docMk/>
          <pc:sldMk cId="4216582557" sldId="284"/>
        </pc:sldMkLst>
        <pc:spChg chg="del">
          <ac:chgData name="Hsu, Robert" userId="a49bd464-34e2-45dd-a34f-7e5b363136eb" providerId="ADAL" clId="{6BB6C5BF-FF8B-47DB-A14B-4C5926352A07}" dt="2022-11-02T22:51:22.703" v="185" actId="478"/>
          <ac:spMkLst>
            <pc:docMk/>
            <pc:sldMk cId="4216582557" sldId="284"/>
            <ac:spMk id="6" creationId="{1304BA2D-C2A1-9E40-973A-7D14DC62C482}"/>
          </ac:spMkLst>
        </pc:spChg>
        <pc:spChg chg="mod">
          <ac:chgData name="Hsu, Robert" userId="a49bd464-34e2-45dd-a34f-7e5b363136eb" providerId="ADAL" clId="{6BB6C5BF-FF8B-47DB-A14B-4C5926352A07}" dt="2022-11-02T22:53:35.720" v="235" actId="14100"/>
          <ac:spMkLst>
            <pc:docMk/>
            <pc:sldMk cId="4216582557" sldId="284"/>
            <ac:spMk id="7" creationId="{99B91626-4903-4C49-A433-591A1984AA92}"/>
          </ac:spMkLst>
        </pc:spChg>
        <pc:spChg chg="add mod">
          <ac:chgData name="Hsu, Robert" userId="a49bd464-34e2-45dd-a34f-7e5b363136eb" providerId="ADAL" clId="{6BB6C5BF-FF8B-47DB-A14B-4C5926352A07}" dt="2022-11-02T22:51:43.784" v="188"/>
          <ac:spMkLst>
            <pc:docMk/>
            <pc:sldMk cId="4216582557" sldId="284"/>
            <ac:spMk id="9" creationId="{E69BDFEA-158E-4831-BAC3-B9649668D23E}"/>
          </ac:spMkLst>
        </pc:spChg>
        <pc:spChg chg="add mod">
          <ac:chgData name="Hsu, Robert" userId="a49bd464-34e2-45dd-a34f-7e5b363136eb" providerId="ADAL" clId="{6BB6C5BF-FF8B-47DB-A14B-4C5926352A07}" dt="2022-11-02T22:52:02.807" v="192" actId="1076"/>
          <ac:spMkLst>
            <pc:docMk/>
            <pc:sldMk cId="4216582557" sldId="284"/>
            <ac:spMk id="10" creationId="{C7CD9A1D-1648-42D0-82FC-B4B2F7B38FE4}"/>
          </ac:spMkLst>
        </pc:spChg>
        <pc:spChg chg="add del">
          <ac:chgData name="Hsu, Robert" userId="a49bd464-34e2-45dd-a34f-7e5b363136eb" providerId="ADAL" clId="{6BB6C5BF-FF8B-47DB-A14B-4C5926352A07}" dt="2022-11-02T22:52:17.049" v="194" actId="22"/>
          <ac:spMkLst>
            <pc:docMk/>
            <pc:sldMk cId="4216582557" sldId="284"/>
            <ac:spMk id="11" creationId="{167B4021-4EBC-4D19-B5AB-76104ABE6EBA}"/>
          </ac:spMkLst>
        </pc:spChg>
        <pc:graphicFrameChg chg="mod modGraphic">
          <ac:chgData name="Hsu, Robert" userId="a49bd464-34e2-45dd-a34f-7e5b363136eb" providerId="ADAL" clId="{6BB6C5BF-FF8B-47DB-A14B-4C5926352A07}" dt="2022-11-12T02:30:57.746" v="580" actId="20577"/>
          <ac:graphicFrameMkLst>
            <pc:docMk/>
            <pc:sldMk cId="4216582557" sldId="284"/>
            <ac:graphicFrameMk id="5" creationId="{A7EDCC75-8B13-4443-9F6C-D67B8663E9CD}"/>
          </ac:graphicFrameMkLst>
        </pc:graphicFrameChg>
        <pc:graphicFrameChg chg="del">
          <ac:chgData name="Hsu, Robert" userId="a49bd464-34e2-45dd-a34f-7e5b363136eb" providerId="ADAL" clId="{6BB6C5BF-FF8B-47DB-A14B-4C5926352A07}" dt="2022-11-02T22:51:21.059" v="184" actId="478"/>
          <ac:graphicFrameMkLst>
            <pc:docMk/>
            <pc:sldMk cId="4216582557" sldId="284"/>
            <ac:graphicFrameMk id="8" creationId="{8EBD2D68-A99B-4608-A0AE-C6D7D8F608FC}"/>
          </ac:graphicFrameMkLst>
        </pc:graphicFrameChg>
        <pc:graphicFrameChg chg="add mod">
          <ac:chgData name="Hsu, Robert" userId="a49bd464-34e2-45dd-a34f-7e5b363136eb" providerId="ADAL" clId="{6BB6C5BF-FF8B-47DB-A14B-4C5926352A07}" dt="2022-11-02T22:52:29.663" v="197" actId="1076"/>
          <ac:graphicFrameMkLst>
            <pc:docMk/>
            <pc:sldMk cId="4216582557" sldId="284"/>
            <ac:graphicFrameMk id="12" creationId="{98897290-866C-454D-82CA-3D08513FE12F}"/>
          </ac:graphicFrameMkLst>
        </pc:graphicFrameChg>
      </pc:sldChg>
      <pc:sldChg chg="del">
        <pc:chgData name="Hsu, Robert" userId="a49bd464-34e2-45dd-a34f-7e5b363136eb" providerId="ADAL" clId="{6BB6C5BF-FF8B-47DB-A14B-4C5926352A07}" dt="2022-11-02T22:53:57.387" v="236" actId="2696"/>
        <pc:sldMkLst>
          <pc:docMk/>
          <pc:sldMk cId="3929339808" sldId="285"/>
        </pc:sldMkLst>
      </pc:sldChg>
      <pc:sldChg chg="addSp delSp modSp mod">
        <pc:chgData name="Hsu, Robert" userId="a49bd464-34e2-45dd-a34f-7e5b363136eb" providerId="ADAL" clId="{6BB6C5BF-FF8B-47DB-A14B-4C5926352A07}" dt="2022-11-12T02:38:34.095" v="693" actId="1076"/>
        <pc:sldMkLst>
          <pc:docMk/>
          <pc:sldMk cId="1198277541" sldId="286"/>
        </pc:sldMkLst>
        <pc:spChg chg="del">
          <ac:chgData name="Hsu, Robert" userId="a49bd464-34e2-45dd-a34f-7e5b363136eb" providerId="ADAL" clId="{6BB6C5BF-FF8B-47DB-A14B-4C5926352A07}" dt="2022-11-02T22:55:23.361" v="273" actId="478"/>
          <ac:spMkLst>
            <pc:docMk/>
            <pc:sldMk cId="1198277541" sldId="286"/>
            <ac:spMk id="6" creationId="{65B0F2F4-C449-4D40-A771-D1A0BCAEF52A}"/>
          </ac:spMkLst>
        </pc:spChg>
        <pc:spChg chg="del mod">
          <ac:chgData name="Hsu, Robert" userId="a49bd464-34e2-45dd-a34f-7e5b363136eb" providerId="ADAL" clId="{6BB6C5BF-FF8B-47DB-A14B-4C5926352A07}" dt="2022-11-02T22:55:39.393" v="279" actId="478"/>
          <ac:spMkLst>
            <pc:docMk/>
            <pc:sldMk cId="1198277541" sldId="286"/>
            <ac:spMk id="7" creationId="{1611AB69-8E61-E944-9D1D-D4C3199FB940}"/>
          </ac:spMkLst>
        </pc:spChg>
        <pc:spChg chg="del">
          <ac:chgData name="Hsu, Robert" userId="a49bd464-34e2-45dd-a34f-7e5b363136eb" providerId="ADAL" clId="{6BB6C5BF-FF8B-47DB-A14B-4C5926352A07}" dt="2022-11-02T22:55:46.306" v="281" actId="478"/>
          <ac:spMkLst>
            <pc:docMk/>
            <pc:sldMk cId="1198277541" sldId="286"/>
            <ac:spMk id="9" creationId="{67A04372-D81F-8646-B1F4-9A94BECF6C11}"/>
          </ac:spMkLst>
        </pc:spChg>
        <pc:spChg chg="mod">
          <ac:chgData name="Hsu, Robert" userId="a49bd464-34e2-45dd-a34f-7e5b363136eb" providerId="ADAL" clId="{6BB6C5BF-FF8B-47DB-A14B-4C5926352A07}" dt="2022-11-12T02:38:34.095" v="693" actId="1076"/>
          <ac:spMkLst>
            <pc:docMk/>
            <pc:sldMk cId="1198277541" sldId="286"/>
            <ac:spMk id="11" creationId="{647AF9AB-9F49-BB4C-BF59-3D3DD0C7AA30}"/>
          </ac:spMkLst>
        </pc:spChg>
        <pc:spChg chg="add del mod">
          <ac:chgData name="Hsu, Robert" userId="a49bd464-34e2-45dd-a34f-7e5b363136eb" providerId="ADAL" clId="{6BB6C5BF-FF8B-47DB-A14B-4C5926352A07}" dt="2022-11-12T02:35:57.559" v="685" actId="478"/>
          <ac:spMkLst>
            <pc:docMk/>
            <pc:sldMk cId="1198277541" sldId="286"/>
            <ac:spMk id="14" creationId="{6E23B94A-2766-4EA9-8247-A35B6D180828}"/>
          </ac:spMkLst>
        </pc:spChg>
        <pc:spChg chg="add del mod">
          <ac:chgData name="Hsu, Robert" userId="a49bd464-34e2-45dd-a34f-7e5b363136eb" providerId="ADAL" clId="{6BB6C5BF-FF8B-47DB-A14B-4C5926352A07}" dt="2022-11-12T02:35:59.125" v="686" actId="478"/>
          <ac:spMkLst>
            <pc:docMk/>
            <pc:sldMk cId="1198277541" sldId="286"/>
            <ac:spMk id="15" creationId="{47C7EB55-C20D-47E9-94D5-165010D9C5B2}"/>
          </ac:spMkLst>
        </pc:spChg>
        <pc:graphicFrameChg chg="mod modGraphic">
          <ac:chgData name="Hsu, Robert" userId="a49bd464-34e2-45dd-a34f-7e5b363136eb" providerId="ADAL" clId="{6BB6C5BF-FF8B-47DB-A14B-4C5926352A07}" dt="2022-11-12T02:38:27.869" v="691"/>
          <ac:graphicFrameMkLst>
            <pc:docMk/>
            <pc:sldMk cId="1198277541" sldId="286"/>
            <ac:graphicFrameMk id="5" creationId="{4CD3093F-B977-FB41-991E-F6F0DBB8415D}"/>
          </ac:graphicFrameMkLst>
        </pc:graphicFrameChg>
        <pc:graphicFrameChg chg="del mod modGraphic">
          <ac:chgData name="Hsu, Robert" userId="a49bd464-34e2-45dd-a34f-7e5b363136eb" providerId="ADAL" clId="{6BB6C5BF-FF8B-47DB-A14B-4C5926352A07}" dt="2022-11-12T02:38:30.451" v="692" actId="478"/>
          <ac:graphicFrameMkLst>
            <pc:docMk/>
            <pc:sldMk cId="1198277541" sldId="286"/>
            <ac:graphicFrameMk id="10" creationId="{9A135025-14D0-1A40-8EE5-6A41F5DEE826}"/>
          </ac:graphicFrameMkLst>
        </pc:graphicFrameChg>
        <pc:graphicFrameChg chg="del">
          <ac:chgData name="Hsu, Robert" userId="a49bd464-34e2-45dd-a34f-7e5b363136eb" providerId="ADAL" clId="{6BB6C5BF-FF8B-47DB-A14B-4C5926352A07}" dt="2022-11-02T22:55:20.277" v="272" actId="478"/>
          <ac:graphicFrameMkLst>
            <pc:docMk/>
            <pc:sldMk cId="1198277541" sldId="286"/>
            <ac:graphicFrameMk id="12" creationId="{D4297474-B8C2-4AF1-A96F-79D013C748DF}"/>
          </ac:graphicFrameMkLst>
        </pc:graphicFrameChg>
        <pc:graphicFrameChg chg="del">
          <ac:chgData name="Hsu, Robert" userId="a49bd464-34e2-45dd-a34f-7e5b363136eb" providerId="ADAL" clId="{6BB6C5BF-FF8B-47DB-A14B-4C5926352A07}" dt="2022-11-02T22:55:42.756" v="280" actId="478"/>
          <ac:graphicFrameMkLst>
            <pc:docMk/>
            <pc:sldMk cId="1198277541" sldId="286"/>
            <ac:graphicFrameMk id="13" creationId="{F929EE15-240C-40FD-A55E-1EA5CBEEEC99}"/>
          </ac:graphicFrameMkLst>
        </pc:graphicFrameChg>
      </pc:sldChg>
      <pc:sldChg chg="del">
        <pc:chgData name="Hsu, Robert" userId="a49bd464-34e2-45dd-a34f-7e5b363136eb" providerId="ADAL" clId="{6BB6C5BF-FF8B-47DB-A14B-4C5926352A07}" dt="2022-11-02T22:42:02.226" v="17" actId="2696"/>
        <pc:sldMkLst>
          <pc:docMk/>
          <pc:sldMk cId="1580468348" sldId="288"/>
        </pc:sldMkLst>
      </pc:sldChg>
      <pc:sldChg chg="del">
        <pc:chgData name="Hsu, Robert" userId="a49bd464-34e2-45dd-a34f-7e5b363136eb" providerId="ADAL" clId="{6BB6C5BF-FF8B-47DB-A14B-4C5926352A07}" dt="2022-11-02T22:42:08.103" v="20" actId="2696"/>
        <pc:sldMkLst>
          <pc:docMk/>
          <pc:sldMk cId="870329897" sldId="289"/>
        </pc:sldMkLst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292251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51455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872320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20581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12936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3011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36768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29549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54003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6919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27602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6114C7B-0902-B847-890C-2325F9DE474E}" type="datetimeFigureOut">
              <a:rPr lang="en-US" smtClean="0"/>
              <a:t>11/11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37386-59DD-C94A-89F3-3039C82EE9A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3438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Table 6">
            <a:extLst>
              <a:ext uri="{FF2B5EF4-FFF2-40B4-BE49-F238E27FC236}">
                <a16:creationId xmlns:a16="http://schemas.microsoft.com/office/drawing/2014/main" id="{6F181412-1BB4-1344-A0D5-6C49E8C8A65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01398364"/>
              </p:ext>
            </p:extLst>
          </p:nvPr>
        </p:nvGraphicFramePr>
        <p:xfrm>
          <a:off x="477043" y="339227"/>
          <a:ext cx="6818313" cy="726528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13209">
                  <a:extLst>
                    <a:ext uri="{9D8B030D-6E8A-4147-A177-3AD203B41FA5}">
                      <a16:colId xmlns:a16="http://schemas.microsoft.com/office/drawing/2014/main" val="2236616620"/>
                    </a:ext>
                  </a:extLst>
                </a:gridCol>
                <a:gridCol w="602356">
                  <a:extLst>
                    <a:ext uri="{9D8B030D-6E8A-4147-A177-3AD203B41FA5}">
                      <a16:colId xmlns:a16="http://schemas.microsoft.com/office/drawing/2014/main" val="2741125883"/>
                    </a:ext>
                  </a:extLst>
                </a:gridCol>
                <a:gridCol w="734349">
                  <a:extLst>
                    <a:ext uri="{9D8B030D-6E8A-4147-A177-3AD203B41FA5}">
                      <a16:colId xmlns:a16="http://schemas.microsoft.com/office/drawing/2014/main" val="2681745967"/>
                    </a:ext>
                  </a:extLst>
                </a:gridCol>
                <a:gridCol w="681775">
                  <a:extLst>
                    <a:ext uri="{9D8B030D-6E8A-4147-A177-3AD203B41FA5}">
                      <a16:colId xmlns:a16="http://schemas.microsoft.com/office/drawing/2014/main" val="231662972"/>
                    </a:ext>
                  </a:extLst>
                </a:gridCol>
                <a:gridCol w="786922">
                  <a:extLst>
                    <a:ext uri="{9D8B030D-6E8A-4147-A177-3AD203B41FA5}">
                      <a16:colId xmlns:a16="http://schemas.microsoft.com/office/drawing/2014/main" val="3172552695"/>
                    </a:ext>
                  </a:extLst>
                </a:gridCol>
                <a:gridCol w="629762">
                  <a:extLst>
                    <a:ext uri="{9D8B030D-6E8A-4147-A177-3AD203B41FA5}">
                      <a16:colId xmlns:a16="http://schemas.microsoft.com/office/drawing/2014/main" val="1972961027"/>
                    </a:ext>
                  </a:extLst>
                </a:gridCol>
                <a:gridCol w="629762">
                  <a:extLst>
                    <a:ext uri="{9D8B030D-6E8A-4147-A177-3AD203B41FA5}">
                      <a16:colId xmlns:a16="http://schemas.microsoft.com/office/drawing/2014/main" val="3042781812"/>
                    </a:ext>
                  </a:extLst>
                </a:gridCol>
                <a:gridCol w="520639">
                  <a:extLst>
                    <a:ext uri="{9D8B030D-6E8A-4147-A177-3AD203B41FA5}">
                      <a16:colId xmlns:a16="http://schemas.microsoft.com/office/drawing/2014/main" val="2625623000"/>
                    </a:ext>
                  </a:extLst>
                </a:gridCol>
                <a:gridCol w="737764">
                  <a:extLst>
                    <a:ext uri="{9D8B030D-6E8A-4147-A177-3AD203B41FA5}">
                      <a16:colId xmlns:a16="http://schemas.microsoft.com/office/drawing/2014/main" val="3660493260"/>
                    </a:ext>
                  </a:extLst>
                </a:gridCol>
                <a:gridCol w="681775">
                  <a:extLst>
                    <a:ext uri="{9D8B030D-6E8A-4147-A177-3AD203B41FA5}">
                      <a16:colId xmlns:a16="http://schemas.microsoft.com/office/drawing/2014/main" val="911996928"/>
                    </a:ext>
                  </a:extLst>
                </a:gridCol>
              </a:tblGrid>
              <a:tr h="39571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Odds Ratio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Non-Hispanic Whit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Non-Hispanic Black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Hispanic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Chines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Japanes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orean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Vietnames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South Asian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Other Southeast Asians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427155560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A. Histology:</a:t>
                      </a: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482688615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apillar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438200231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6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2.1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3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2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2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5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3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3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98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743416348"/>
                  </a:ext>
                </a:extLst>
              </a:tr>
              <a:tr h="2638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50-1.492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886-2.37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45-1.13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08-1.06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103-1.30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247-0.811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56-1.33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49-1.25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550-2.54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137988913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-valu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40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85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26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149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38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147571477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Follicular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5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5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2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2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2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76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7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2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5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039127812"/>
                  </a:ext>
                </a:extLst>
              </a:tr>
              <a:tr h="2638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72-0.83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99-0.52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11-1.15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942-1.337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56-1.37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18-2.36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34-0.94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96-1.31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70-0.90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135664952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-valu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83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167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90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119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58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102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4270913230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Medullar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855652473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2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0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     0.38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7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2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2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0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3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3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22875237"/>
                  </a:ext>
                </a:extLst>
              </a:tr>
              <a:tr h="2638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39-0.45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11-0.44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280-0.53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73-0.87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69-1.85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91-1.32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02-1.23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06-0.55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96-2.33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112031623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-valu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</a:rPr>
                        <a:t>&lt;0.0001</a:t>
                      </a:r>
                      <a:endParaRPr lang="en-US" sz="1000" b="1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107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45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93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17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25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4187931861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naplastic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832201972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9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1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7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2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65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3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4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52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0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27799545"/>
                  </a:ext>
                </a:extLst>
              </a:tr>
              <a:tr h="2638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31-1.54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97-1.47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22-1.93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29-2.18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14-3.81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75-2.66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23-2.53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83-2.96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66-0.96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43762284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-value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159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42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54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104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41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49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00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14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393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200459508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B. Stage IV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785337895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52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8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7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3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4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7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79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83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4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4264636185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74-1.68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59-1.75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26-1.64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34-1.56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43-1.10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19-1.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22-2.27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24-2.35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34-1.49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605167317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-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5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19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334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0" dirty="0">
                          <a:effectLst/>
                        </a:rPr>
                        <a:t>0.7976</a:t>
                      </a:r>
                      <a:endParaRPr lang="en-US" sz="10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7050452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C. T4 Tumor Stag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6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5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0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3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12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7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3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8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1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660233265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95% CI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74-1.55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45-1.38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39-1.07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21-1.35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37-1.34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52-1.10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05-1.28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21-1.46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736-1.14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974473159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-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33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09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47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415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3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30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242990149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D. N1 Nodal Stag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4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88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0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4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1.00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0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9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8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9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780431058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95% CI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48-1.43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677-2.11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41-0.97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38-1.15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24-1.23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83-1.04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35-1.37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50-1.14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53-1.41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734769627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-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74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41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29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169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148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39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70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796158573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E. </a:t>
                      </a:r>
                      <a:r>
                        <a:rPr lang="en-US" sz="800" dirty="0" err="1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Lymphovascular</a:t>
                      </a:r>
                      <a:r>
                        <a:rPr lang="en-US" sz="8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 </a:t>
                      </a:r>
                    </a:p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+mn-lt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Invasion</a:t>
                      </a:r>
                      <a:endParaRPr lang="en-US" sz="1000" dirty="0">
                        <a:effectLst/>
                        <a:latin typeface="+mn-lt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4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4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9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2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7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7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5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9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1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982573360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78-1.62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93-1.74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84-1.126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85-1.706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50-2.00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85-1.65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14-1.44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91-1.77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14-1.44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4197810166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-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2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76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2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09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064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319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78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3681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487572585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F. Multifocality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840779552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9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642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     1.12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         1.134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95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05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24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052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059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524775408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95% CI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107-1.280 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468-1.834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44-1.213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17-1.263 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778-1.17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821-1.368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75-1.435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902-1.225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821-1.368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735398276"/>
                  </a:ext>
                </a:extLst>
              </a:tr>
              <a:tr h="158286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-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22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236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83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450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31</a:t>
                      </a:r>
                      <a:endParaRPr lang="en-US" sz="10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5237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6570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819989806"/>
                  </a:ext>
                </a:extLst>
              </a:tr>
            </a:tbl>
          </a:graphicData>
        </a:graphic>
      </p:graphicFrame>
      <p:sp>
        <p:nvSpPr>
          <p:cNvPr id="8" name="Rectangle 7">
            <a:extLst>
              <a:ext uri="{FF2B5EF4-FFF2-40B4-BE49-F238E27FC236}">
                <a16:creationId xmlns:a16="http://schemas.microsoft.com/office/drawing/2014/main" id="{F3077FF9-5133-BD40-838A-B93A5FD945D7}"/>
              </a:ext>
            </a:extLst>
          </p:cNvPr>
          <p:cNvSpPr/>
          <p:nvPr/>
        </p:nvSpPr>
        <p:spPr>
          <a:xfrm>
            <a:off x="477043" y="7926883"/>
            <a:ext cx="6818313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1: Odds Ratio of Disease </a:t>
            </a:r>
            <a:r>
              <a:rPr lang="en-US" sz="1200" b="1" dirty="0" err="1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haracterstics</a:t>
            </a: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 Filipinos compared to other race/ethnicities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6078998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>
            <a:extLst>
              <a:ext uri="{FF2B5EF4-FFF2-40B4-BE49-F238E27FC236}">
                <a16:creationId xmlns:a16="http://schemas.microsoft.com/office/drawing/2014/main" id="{4CD3093F-B977-FB41-991E-F6F0DBB8415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38740107"/>
              </p:ext>
            </p:extLst>
          </p:nvPr>
        </p:nvGraphicFramePr>
        <p:xfrm>
          <a:off x="309590" y="926906"/>
          <a:ext cx="7194901" cy="1562814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862260">
                  <a:extLst>
                    <a:ext uri="{9D8B030D-6E8A-4147-A177-3AD203B41FA5}">
                      <a16:colId xmlns:a16="http://schemas.microsoft.com/office/drawing/2014/main" val="3545799041"/>
                    </a:ext>
                  </a:extLst>
                </a:gridCol>
                <a:gridCol w="638690">
                  <a:extLst>
                    <a:ext uri="{9D8B030D-6E8A-4147-A177-3AD203B41FA5}">
                      <a16:colId xmlns:a16="http://schemas.microsoft.com/office/drawing/2014/main" val="3940071349"/>
                    </a:ext>
                  </a:extLst>
                </a:gridCol>
                <a:gridCol w="778644">
                  <a:extLst>
                    <a:ext uri="{9D8B030D-6E8A-4147-A177-3AD203B41FA5}">
                      <a16:colId xmlns:a16="http://schemas.microsoft.com/office/drawing/2014/main" val="1764367451"/>
                    </a:ext>
                  </a:extLst>
                </a:gridCol>
                <a:gridCol w="722899">
                  <a:extLst>
                    <a:ext uri="{9D8B030D-6E8A-4147-A177-3AD203B41FA5}">
                      <a16:colId xmlns:a16="http://schemas.microsoft.com/office/drawing/2014/main" val="3331234249"/>
                    </a:ext>
                  </a:extLst>
                </a:gridCol>
                <a:gridCol w="834388">
                  <a:extLst>
                    <a:ext uri="{9D8B030D-6E8A-4147-A177-3AD203B41FA5}">
                      <a16:colId xmlns:a16="http://schemas.microsoft.com/office/drawing/2014/main" val="2564426593"/>
                    </a:ext>
                  </a:extLst>
                </a:gridCol>
                <a:gridCol w="667748">
                  <a:extLst>
                    <a:ext uri="{9D8B030D-6E8A-4147-A177-3AD203B41FA5}">
                      <a16:colId xmlns:a16="http://schemas.microsoft.com/office/drawing/2014/main" val="948857889"/>
                    </a:ext>
                  </a:extLst>
                </a:gridCol>
                <a:gridCol w="633064">
                  <a:extLst>
                    <a:ext uri="{9D8B030D-6E8A-4147-A177-3AD203B41FA5}">
                      <a16:colId xmlns:a16="http://schemas.microsoft.com/office/drawing/2014/main" val="728041277"/>
                    </a:ext>
                  </a:extLst>
                </a:gridCol>
                <a:gridCol w="665145">
                  <a:extLst>
                    <a:ext uri="{9D8B030D-6E8A-4147-A177-3AD203B41FA5}">
                      <a16:colId xmlns:a16="http://schemas.microsoft.com/office/drawing/2014/main" val="3922359846"/>
                    </a:ext>
                  </a:extLst>
                </a:gridCol>
                <a:gridCol w="669164">
                  <a:extLst>
                    <a:ext uri="{9D8B030D-6E8A-4147-A177-3AD203B41FA5}">
                      <a16:colId xmlns:a16="http://schemas.microsoft.com/office/drawing/2014/main" val="1864907537"/>
                    </a:ext>
                  </a:extLst>
                </a:gridCol>
                <a:gridCol w="722899">
                  <a:extLst>
                    <a:ext uri="{9D8B030D-6E8A-4147-A177-3AD203B41FA5}">
                      <a16:colId xmlns:a16="http://schemas.microsoft.com/office/drawing/2014/main" val="879323906"/>
                    </a:ext>
                  </a:extLst>
                </a:gridCol>
              </a:tblGrid>
              <a:tr h="35981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A. Surgery  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Non-Hispanic White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Non-Hispanic Black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Hispanic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Chinese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Japanese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Korean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Vietnamese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South Asian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Other Southeast Asians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2172417713"/>
                  </a:ext>
                </a:extLst>
              </a:tr>
              <a:tr h="1384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 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95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289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832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4</a:t>
                      </a: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58</a:t>
                      </a: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21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95</a:t>
                      </a: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872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15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533662759"/>
                  </a:ext>
                </a:extLst>
              </a:tr>
              <a:tr h="230684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95% CI</a:t>
                      </a:r>
                      <a:endParaRPr lang="en-US" sz="10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873-1.035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142-1.455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761-0.910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875-1.12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748-1.227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1.009-1.45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843-1.175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726-1.04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866-1.53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005029635"/>
                  </a:ext>
                </a:extLst>
              </a:tr>
              <a:tr h="1384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p-value</a:t>
                      </a:r>
                      <a:endParaRPr lang="en-US" sz="10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2424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&lt;0.0001</a:t>
                      </a: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1" dirty="0">
                          <a:effectLst/>
                        </a:rPr>
                        <a:t>&lt;0.0001</a:t>
                      </a:r>
                      <a:endParaRPr lang="en-US" sz="8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9198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735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effectLst/>
                        </a:rPr>
                        <a:t>0.0964</a:t>
                      </a:r>
                      <a:endParaRPr lang="en-US" sz="8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953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dirty="0">
                          <a:effectLst/>
                        </a:rPr>
                        <a:t>0.1441</a:t>
                      </a:r>
                      <a:endParaRPr lang="en-US" sz="8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800" b="0" dirty="0">
                          <a:effectLst/>
                        </a:rPr>
                        <a:t>0.3325</a:t>
                      </a:r>
                      <a:endParaRPr lang="en-US" sz="800" b="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678257787"/>
                  </a:ext>
                </a:extLst>
              </a:tr>
              <a:tr h="1384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B. Radiation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833682806"/>
                  </a:ext>
                </a:extLst>
              </a:tr>
              <a:tr h="1384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 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92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546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73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40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  <a:latin typeface="Times New Roman" panose="02020603050405020304" pitchFamily="18" charset="0"/>
                          <a:ea typeface="Times New Roman" panose="02020603050405020304" pitchFamily="18" charset="0"/>
                          <a:cs typeface="Times New Roman" panose="02020603050405020304" pitchFamily="18" charset="0"/>
                        </a:rPr>
                        <a:t>0.912</a:t>
                      </a: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43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205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26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633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614165138"/>
                  </a:ext>
                </a:extLst>
              </a:tr>
              <a:tr h="1384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95% CI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123-1.264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414-1.686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09-1.142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42-1.247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779-1.067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98-1.40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075-1.351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986-1.287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322-1.996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1122990662"/>
                  </a:ext>
                </a:extLst>
              </a:tr>
              <a:tr h="138410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-value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254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40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2490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06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0014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0785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&lt;0.0001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357" marR="59357" marT="0" marB="0"/>
                </a:tc>
                <a:extLst>
                  <a:ext uri="{0D108BD9-81ED-4DB2-BD59-A6C34878D82A}">
                    <a16:rowId xmlns:a16="http://schemas.microsoft.com/office/drawing/2014/main" val="3316078914"/>
                  </a:ext>
                </a:extLst>
              </a:tr>
            </a:tbl>
          </a:graphicData>
        </a:graphic>
      </p:graphicFrame>
      <p:sp>
        <p:nvSpPr>
          <p:cNvPr id="11" name="Rectangle 10">
            <a:extLst>
              <a:ext uri="{FF2B5EF4-FFF2-40B4-BE49-F238E27FC236}">
                <a16:creationId xmlns:a16="http://schemas.microsoft.com/office/drawing/2014/main" id="{647AF9AB-9F49-BB4C-BF59-3D3DD0C7AA30}"/>
              </a:ext>
            </a:extLst>
          </p:cNvPr>
          <p:cNvSpPr/>
          <p:nvPr/>
        </p:nvSpPr>
        <p:spPr>
          <a:xfrm>
            <a:off x="309590" y="3093957"/>
            <a:ext cx="7266214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2: Odds Ratio of Surgery/Radiation in Filipinos compared to other race/ethnicities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19827754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>
            <a:extLst>
              <a:ext uri="{FF2B5EF4-FFF2-40B4-BE49-F238E27FC236}">
                <a16:creationId xmlns:a16="http://schemas.microsoft.com/office/drawing/2014/main" id="{54E3888B-9A84-A042-9920-61F2043E5AAA}"/>
              </a:ext>
            </a:extLst>
          </p:cNvPr>
          <p:cNvSpPr/>
          <p:nvPr/>
        </p:nvSpPr>
        <p:spPr>
          <a:xfrm>
            <a:off x="190983" y="7327061"/>
            <a:ext cx="7581417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3: Age Adjusted Mortality Rate (AAMR) in California from 1988-2018 (2015 in Asian subgroups) by Individual Year</a:t>
            </a:r>
            <a:endParaRPr lang="en-US" sz="1200" dirty="0">
              <a:latin typeface="Times New Roman" panose="0202060305040502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8" name="Table 7">
            <a:extLst>
              <a:ext uri="{FF2B5EF4-FFF2-40B4-BE49-F238E27FC236}">
                <a16:creationId xmlns:a16="http://schemas.microsoft.com/office/drawing/2014/main" id="{065B733F-9C50-5849-9B9D-19D082E2640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98597161"/>
              </p:ext>
            </p:extLst>
          </p:nvPr>
        </p:nvGraphicFramePr>
        <p:xfrm>
          <a:off x="190500" y="520700"/>
          <a:ext cx="7416804" cy="635000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867737">
                  <a:extLst>
                    <a:ext uri="{9D8B030D-6E8A-4147-A177-3AD203B41FA5}">
                      <a16:colId xmlns:a16="http://schemas.microsoft.com/office/drawing/2014/main" val="525529873"/>
                    </a:ext>
                  </a:extLst>
                </a:gridCol>
                <a:gridCol w="797380">
                  <a:extLst>
                    <a:ext uri="{9D8B030D-6E8A-4147-A177-3AD203B41FA5}">
                      <a16:colId xmlns:a16="http://schemas.microsoft.com/office/drawing/2014/main" val="1146786902"/>
                    </a:ext>
                  </a:extLst>
                </a:gridCol>
                <a:gridCol w="768065">
                  <a:extLst>
                    <a:ext uri="{9D8B030D-6E8A-4147-A177-3AD203B41FA5}">
                      <a16:colId xmlns:a16="http://schemas.microsoft.com/office/drawing/2014/main" val="3214454579"/>
                    </a:ext>
                  </a:extLst>
                </a:gridCol>
                <a:gridCol w="475118">
                  <a:extLst>
                    <a:ext uri="{9D8B030D-6E8A-4147-A177-3AD203B41FA5}">
                      <a16:colId xmlns:a16="http://schemas.microsoft.com/office/drawing/2014/main" val="3338165644"/>
                    </a:ext>
                  </a:extLst>
                </a:gridCol>
                <a:gridCol w="728768">
                  <a:extLst>
                    <a:ext uri="{9D8B030D-6E8A-4147-A177-3AD203B41FA5}">
                      <a16:colId xmlns:a16="http://schemas.microsoft.com/office/drawing/2014/main" val="1773790039"/>
                    </a:ext>
                  </a:extLst>
                </a:gridCol>
                <a:gridCol w="376132">
                  <a:extLst>
                    <a:ext uri="{9D8B030D-6E8A-4147-A177-3AD203B41FA5}">
                      <a16:colId xmlns:a16="http://schemas.microsoft.com/office/drawing/2014/main" val="2042759824"/>
                    </a:ext>
                  </a:extLst>
                </a:gridCol>
                <a:gridCol w="335256">
                  <a:extLst>
                    <a:ext uri="{9D8B030D-6E8A-4147-A177-3AD203B41FA5}">
                      <a16:colId xmlns:a16="http://schemas.microsoft.com/office/drawing/2014/main" val="1371715290"/>
                    </a:ext>
                  </a:extLst>
                </a:gridCol>
                <a:gridCol w="416279">
                  <a:extLst>
                    <a:ext uri="{9D8B030D-6E8A-4147-A177-3AD203B41FA5}">
                      <a16:colId xmlns:a16="http://schemas.microsoft.com/office/drawing/2014/main" val="3051179025"/>
                    </a:ext>
                  </a:extLst>
                </a:gridCol>
                <a:gridCol w="359603">
                  <a:extLst>
                    <a:ext uri="{9D8B030D-6E8A-4147-A177-3AD203B41FA5}">
                      <a16:colId xmlns:a16="http://schemas.microsoft.com/office/drawing/2014/main" val="2723567491"/>
                    </a:ext>
                  </a:extLst>
                </a:gridCol>
                <a:gridCol w="908778">
                  <a:extLst>
                    <a:ext uri="{9D8B030D-6E8A-4147-A177-3AD203B41FA5}">
                      <a16:colId xmlns:a16="http://schemas.microsoft.com/office/drawing/2014/main" val="2388386822"/>
                    </a:ext>
                  </a:extLst>
                </a:gridCol>
                <a:gridCol w="539403">
                  <a:extLst>
                    <a:ext uri="{9D8B030D-6E8A-4147-A177-3AD203B41FA5}">
                      <a16:colId xmlns:a16="http://schemas.microsoft.com/office/drawing/2014/main" val="3016836549"/>
                    </a:ext>
                  </a:extLst>
                </a:gridCol>
                <a:gridCol w="844285">
                  <a:extLst>
                    <a:ext uri="{9D8B030D-6E8A-4147-A177-3AD203B41FA5}">
                      <a16:colId xmlns:a16="http://schemas.microsoft.com/office/drawing/2014/main" val="2588523235"/>
                    </a:ext>
                  </a:extLst>
                </a:gridCol>
              </a:tblGrid>
              <a:tr h="28225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Year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Non-Hispanic White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Non-Hispanic Black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Hispanic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Asian/Pacific Islander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Chinese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Filipino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Japanese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Korean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u="none" strike="noStrike">
                          <a:solidFill>
                            <a:schemeClr val="bg1"/>
                          </a:solidFill>
                          <a:effectLst/>
                        </a:rPr>
                        <a:t>Other Southeast Asians</a:t>
                      </a:r>
                      <a:endParaRPr lang="en-US" sz="8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South Asian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8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Vietnamese</a:t>
                      </a:r>
                      <a:endParaRPr lang="en-US" sz="8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30054224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1988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44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effectLst/>
                        </a:rPr>
                        <a:t>1.36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3.5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605373020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89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22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210145741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1990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0.6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580638182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91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29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7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597263124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92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0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0.7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990569213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1993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63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2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548786153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1994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effectLst/>
                        </a:rPr>
                        <a:t>1.14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255614010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1995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0.3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1597597891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96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36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3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994234003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97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6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676664085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98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1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7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493554030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1999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0.6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154019904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0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3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5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1234930275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1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09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4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4250679881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2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0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2.1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906213410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03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0.9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026510960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4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20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5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707491942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5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effectLst/>
                        </a:rPr>
                        <a:t>0.77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1.70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910788104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06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5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747197815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7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85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41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283286495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8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7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512059020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09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0.9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3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611398932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10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54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4137984495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11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effectLst/>
                        </a:rPr>
                        <a:t>0.8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1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 dirty="0">
                          <a:effectLst/>
                        </a:rPr>
                        <a:t>0.82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147172718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12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1.17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623091238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13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>
                          <a:effectLst/>
                        </a:rPr>
                        <a:t>2.01</a:t>
                      </a:r>
                      <a:endParaRPr lang="en-US" sz="1000" b="1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1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1821100419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14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4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25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effectLst/>
                        </a:rPr>
                        <a:t>1.10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1951746208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15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9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0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b="1" u="none" strike="noStrike" dirty="0">
                          <a:effectLst/>
                        </a:rPr>
                        <a:t>1.22</a:t>
                      </a:r>
                      <a:endParaRPr lang="en-US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8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8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2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3743835332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16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1.0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3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2221556542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>
                          <a:solidFill>
                            <a:schemeClr val="bg1"/>
                          </a:solidFill>
                          <a:effectLst/>
                        </a:rPr>
                        <a:t>2017</a:t>
                      </a:r>
                      <a:endParaRPr lang="en-US" sz="900" b="1" i="0" u="none" strike="noStrike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4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3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1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1501831243"/>
                  </a:ext>
                </a:extLst>
              </a:tr>
              <a:tr h="195734">
                <a:tc>
                  <a:txBody>
                    <a:bodyPr/>
                    <a:lstStyle/>
                    <a:p>
                      <a:pPr algn="r" fontAlgn="b"/>
                      <a:r>
                        <a:rPr lang="en-US" sz="9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2018</a:t>
                      </a:r>
                      <a:endParaRPr lang="en-US" sz="900" b="1" i="0" u="none" strike="noStrike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>
                    <a:solidFill>
                      <a:schemeClr val="accent1"/>
                    </a:solidFill>
                  </a:tcPr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56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77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r" fontAlgn="b"/>
                      <a:r>
                        <a:rPr lang="en-US" sz="1000" u="none" strike="noStrike">
                          <a:effectLst/>
                        </a:rPr>
                        <a:t>0.69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>
                          <a:effectLst/>
                        </a:rPr>
                        <a:t> </a:t>
                      </a:r>
                      <a:endParaRPr lang="en-US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000" u="none" strike="noStrike" dirty="0">
                          <a:effectLst/>
                        </a:rPr>
                        <a:t> </a:t>
                      </a:r>
                      <a:endParaRPr lang="en-US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303" marR="5303" marT="5303" marB="0" anchor="b"/>
                </a:tc>
                <a:extLst>
                  <a:ext uri="{0D108BD9-81ED-4DB2-BD59-A6C34878D82A}">
                    <a16:rowId xmlns:a16="http://schemas.microsoft.com/office/drawing/2014/main" val="197991171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71924219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>
            <a:extLst>
              <a:ext uri="{FF2B5EF4-FFF2-40B4-BE49-F238E27FC236}">
                <a16:creationId xmlns:a16="http://schemas.microsoft.com/office/drawing/2014/main" id="{99D40D41-F8D5-244F-96CA-26E041772A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0079280"/>
              </p:ext>
            </p:extLst>
          </p:nvPr>
        </p:nvGraphicFramePr>
        <p:xfrm>
          <a:off x="329876" y="845903"/>
          <a:ext cx="6140053" cy="2243527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084808">
                  <a:extLst>
                    <a:ext uri="{9D8B030D-6E8A-4147-A177-3AD203B41FA5}">
                      <a16:colId xmlns:a16="http://schemas.microsoft.com/office/drawing/2014/main" val="471109407"/>
                    </a:ext>
                  </a:extLst>
                </a:gridCol>
                <a:gridCol w="727148">
                  <a:extLst>
                    <a:ext uri="{9D8B030D-6E8A-4147-A177-3AD203B41FA5}">
                      <a16:colId xmlns:a16="http://schemas.microsoft.com/office/drawing/2014/main" val="4269501129"/>
                    </a:ext>
                  </a:extLst>
                </a:gridCol>
                <a:gridCol w="981824">
                  <a:extLst>
                    <a:ext uri="{9D8B030D-6E8A-4147-A177-3AD203B41FA5}">
                      <a16:colId xmlns:a16="http://schemas.microsoft.com/office/drawing/2014/main" val="1918962166"/>
                    </a:ext>
                  </a:extLst>
                </a:gridCol>
                <a:gridCol w="530227">
                  <a:extLst>
                    <a:ext uri="{9D8B030D-6E8A-4147-A177-3AD203B41FA5}">
                      <a16:colId xmlns:a16="http://schemas.microsoft.com/office/drawing/2014/main" val="1978395367"/>
                    </a:ext>
                  </a:extLst>
                </a:gridCol>
                <a:gridCol w="543447">
                  <a:extLst>
                    <a:ext uri="{9D8B030D-6E8A-4147-A177-3AD203B41FA5}">
                      <a16:colId xmlns:a16="http://schemas.microsoft.com/office/drawing/2014/main" val="937969698"/>
                    </a:ext>
                  </a:extLst>
                </a:gridCol>
                <a:gridCol w="559452">
                  <a:extLst>
                    <a:ext uri="{9D8B030D-6E8A-4147-A177-3AD203B41FA5}">
                      <a16:colId xmlns:a16="http://schemas.microsoft.com/office/drawing/2014/main" val="2691391983"/>
                    </a:ext>
                  </a:extLst>
                </a:gridCol>
                <a:gridCol w="734106">
                  <a:extLst>
                    <a:ext uri="{9D8B030D-6E8A-4147-A177-3AD203B41FA5}">
                      <a16:colId xmlns:a16="http://schemas.microsoft.com/office/drawing/2014/main" val="868351565"/>
                    </a:ext>
                  </a:extLst>
                </a:gridCol>
                <a:gridCol w="979041">
                  <a:extLst>
                    <a:ext uri="{9D8B030D-6E8A-4147-A177-3AD203B41FA5}">
                      <a16:colId xmlns:a16="http://schemas.microsoft.com/office/drawing/2014/main" val="3042025251"/>
                    </a:ext>
                  </a:extLst>
                </a:gridCol>
              </a:tblGrid>
              <a:tr h="314901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Race Group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Lower Endpoint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Upper Endpoint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AP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Lower CI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Upper CI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Test Statistic~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ct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P-Value~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717990759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Filipino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1988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</a:rPr>
                        <a:t>2015</a:t>
                      </a:r>
                      <a:endParaRPr lang="en-US" sz="900" b="1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8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</a:rPr>
                        <a:t>-1.1</a:t>
                      </a:r>
                      <a:endParaRPr lang="en-US" sz="900" b="1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>
                          <a:effectLst/>
                        </a:rPr>
                        <a:t>2.7</a:t>
                      </a:r>
                      <a:endParaRPr lang="en-US" sz="900" b="1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9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b="1" dirty="0">
                          <a:effectLst/>
                        </a:rPr>
                        <a:t>0.38</a:t>
                      </a:r>
                      <a:endParaRPr lang="en-US" sz="900" b="1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2810292476"/>
                  </a:ext>
                </a:extLst>
              </a:tr>
              <a:tr h="20993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Asian Pacific Islander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98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201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0.3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.2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7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0.6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55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2891481740"/>
                  </a:ext>
                </a:extLst>
              </a:tr>
              <a:tr h="20993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Non Hispanic White 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8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201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1*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6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6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4.7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&lt; 0.001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3000611719"/>
                  </a:ext>
                </a:extLst>
              </a:tr>
              <a:tr h="20993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Non Hispanic Black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8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201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.3*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4.1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.6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016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1586087947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Hispanic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8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.9*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3.7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0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3631752133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Chinese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8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4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2.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3.4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3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773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298914371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Japanese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8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.6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4.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.7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32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2537758545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Korean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90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0.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4.2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2.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0.4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659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2549065490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Vietnamese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90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5.9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3.6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.4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1.4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158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2759744929"/>
                  </a:ext>
                </a:extLst>
              </a:tr>
              <a:tr h="135625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South Asian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199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3.9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0.4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3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1.3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0.224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1775964768"/>
                  </a:ext>
                </a:extLst>
              </a:tr>
              <a:tr h="209933">
                <a:tc>
                  <a:txBody>
                    <a:bodyPr/>
                    <a:lstStyle/>
                    <a:p>
                      <a:pPr marL="0" marR="0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Other Southeast Asian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1988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201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5.6*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8.5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>
                          <a:effectLst/>
                        </a:rPr>
                        <a:t>-2.7</a:t>
                      </a:r>
                      <a:endParaRPr lang="en-US" sz="90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-3.9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tc>
                  <a:txBody>
                    <a:bodyPr/>
                    <a:lstStyle/>
                    <a:p>
                      <a:pPr marL="0" marR="0" algn="r"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900" dirty="0">
                          <a:effectLst/>
                        </a:rPr>
                        <a:t>0.001</a:t>
                      </a:r>
                      <a:endParaRPr lang="en-US" sz="900" dirty="0">
                        <a:effectLst/>
                        <a:latin typeface="Times New Roman" panose="02020603050405020304" pitchFamily="18" charset="0"/>
                        <a:ea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0382" marR="50382" marT="0" marB="0" anchor="ctr"/>
                </a:tc>
                <a:extLst>
                  <a:ext uri="{0D108BD9-81ED-4DB2-BD59-A6C34878D82A}">
                    <a16:rowId xmlns:a16="http://schemas.microsoft.com/office/drawing/2014/main" val="506075532"/>
                  </a:ext>
                </a:extLst>
              </a:tr>
            </a:tbl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8A6B8EA7-DCBC-E346-9954-5B08FA95DE48}"/>
              </a:ext>
            </a:extLst>
          </p:cNvPr>
          <p:cNvSpPr txBox="1"/>
          <p:nvPr/>
        </p:nvSpPr>
        <p:spPr>
          <a:xfrm>
            <a:off x="937549" y="7106856"/>
            <a:ext cx="1847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endParaRPr lang="en-US" dirty="0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93D813AD-107F-AE4A-B472-868A7360B4EF}"/>
              </a:ext>
            </a:extLst>
          </p:cNvPr>
          <p:cNvSpPr txBox="1"/>
          <p:nvPr/>
        </p:nvSpPr>
        <p:spPr>
          <a:xfrm>
            <a:off x="95491" y="4395277"/>
            <a:ext cx="7581418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l Table 4: Average Annual Percent Change (AAPC) of AAMR in California from 1988-2018 (2015 in Asian subgroups)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93377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0921</TotalTime>
  <Words>1092</Words>
  <Application>Microsoft Office PowerPoint</Application>
  <PresentationFormat>Custom</PresentationFormat>
  <Paragraphs>878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yroid Carcinoma In Filipinos</dc:title>
  <dc:creator>Robert Hsu</dc:creator>
  <cp:lastModifiedBy>Hsu, Robert</cp:lastModifiedBy>
  <cp:revision>17</cp:revision>
  <dcterms:created xsi:type="dcterms:W3CDTF">2022-02-16T00:35:42Z</dcterms:created>
  <dcterms:modified xsi:type="dcterms:W3CDTF">2022-11-12T02:38:46Z</dcterms:modified>
</cp:coreProperties>
</file>